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636AE-3C87-4EC4-8D2B-6AF6AF6BA3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C2CE9-8133-4D22-8B55-657FD217D3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E111D-178F-4657-B1B6-9C3CF26CA1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6FEBF-8551-49C7-A7A7-1F4442581F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97B19-0024-4CEE-BA03-5C3FA0A49D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B344D-FA0A-4EC7-811C-482293F858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4118A6-380D-4614-A85A-6B256A8637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67730F-B028-4D2D-8EDB-EB04E0F69E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0FE6B-9613-4C51-A123-5169F728F1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09190-C004-43EF-A3E9-DE31C16FBE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53474E-1528-4F6D-B5A2-109ABA2C3B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5B6C7-98BC-4F67-8D90-773B90480F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AB296C-94A1-4B2D-8A2A-8A1E73C6295A}" type="slidenum">
              <a:rPr b="0" lang="fi-FI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577800" y="1728720"/>
            <a:ext cx="5667120" cy="21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Database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SwissProt 2011_11 (533049 sequences; 189064225 residues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Taxonomy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Other Bacteria (42100 sequence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Protein hits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</a:t>
            </a:r>
            <a:r>
              <a:rPr b="1" lang="fi-FI" sz="1200" spc="-1" strike="noStrike" u="sng">
                <a:solidFill>
                  <a:srgbClr val="000000"/>
                </a:solidFill>
                <a:uFillTx/>
                <a:latin typeface="Calibri"/>
              </a:rPr>
              <a:t>CPG1_PORGN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Gingipain R1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Origin Species=Porphyromonas gingivalis  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Gene Name=rgpA 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 u="sng">
                <a:solidFill>
                  <a:srgbClr val="000000"/>
                </a:solidFill>
                <a:uFillTx/>
                <a:latin typeface="Calibri"/>
              </a:rPr>
              <a:t>DHE2_PORG3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NAD-specific glutamate dehydrogenas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Origin Species=Porphyromonas gingivalis (strain ATCC 33277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Gene Name=gd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Mascot Score Histogr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620640" y="3608280"/>
            <a:ext cx="3635280" cy="1920960"/>
          </a:xfrm>
          <a:prstGeom prst="rect">
            <a:avLst/>
          </a:prstGeom>
          <a:ln w="0">
            <a:noFill/>
          </a:ln>
        </p:spPr>
      </p:pic>
      <p:sp>
        <p:nvSpPr>
          <p:cNvPr id="43" name="TextBox 6"/>
          <p:cNvSpPr/>
          <p:nvPr/>
        </p:nvSpPr>
        <p:spPr>
          <a:xfrm>
            <a:off x="3641400" y="4287960"/>
            <a:ext cx="1614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Gingipain R1 (score 89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4" name="Straight Arrow Connector 7"/>
          <p:cNvCxnSpPr/>
          <p:nvPr/>
        </p:nvCxnSpPr>
        <p:spPr>
          <a:xfrm>
            <a:off x="3755520" y="4564080"/>
            <a:ext cx="1080" cy="2181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45" name="TextBox 8"/>
          <p:cNvSpPr/>
          <p:nvPr/>
        </p:nvSpPr>
        <p:spPr>
          <a:xfrm>
            <a:off x="2603880" y="3568680"/>
            <a:ext cx="2631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NAD-specific glutamate dehydrogena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(score 5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6" name="Straight Arrow Connector 9"/>
          <p:cNvCxnSpPr/>
          <p:nvPr/>
        </p:nvCxnSpPr>
        <p:spPr>
          <a:xfrm>
            <a:off x="2674440" y="4089240"/>
            <a:ext cx="1080" cy="6724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pic>
        <p:nvPicPr>
          <p:cNvPr id="47" name="Object 11" descr=""/>
          <p:cNvPicPr/>
          <p:nvPr/>
        </p:nvPicPr>
        <p:blipFill>
          <a:blip r:embed="rId2"/>
          <a:stretch/>
        </p:blipFill>
        <p:spPr>
          <a:xfrm>
            <a:off x="843120" y="5745240"/>
            <a:ext cx="5136840" cy="3359160"/>
          </a:xfrm>
          <a:prstGeom prst="rect">
            <a:avLst/>
          </a:prstGeom>
          <a:ln w="0">
            <a:noFill/>
          </a:ln>
        </p:spPr>
      </p:pic>
      <p:sp>
        <p:nvSpPr>
          <p:cNvPr id="48" name="TextBox 12"/>
          <p:cNvSpPr/>
          <p:nvPr/>
        </p:nvSpPr>
        <p:spPr>
          <a:xfrm>
            <a:off x="305280" y="155880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"/>
          <p:cNvSpPr/>
          <p:nvPr/>
        </p:nvSpPr>
        <p:spPr>
          <a:xfrm>
            <a:off x="437400" y="550692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1"/>
          <p:cNvSpPr/>
          <p:nvPr/>
        </p:nvSpPr>
        <p:spPr>
          <a:xfrm>
            <a:off x="168480" y="20016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3" descr=""/>
          <p:cNvPicPr/>
          <p:nvPr/>
        </p:nvPicPr>
        <p:blipFill>
          <a:blip r:embed="rId1"/>
          <a:stretch/>
        </p:blipFill>
        <p:spPr>
          <a:xfrm>
            <a:off x="-4680" y="546120"/>
            <a:ext cx="6858000" cy="4005360"/>
          </a:xfrm>
          <a:prstGeom prst="rect">
            <a:avLst/>
          </a:prstGeom>
          <a:ln w="0">
            <a:noFill/>
          </a:ln>
        </p:spPr>
      </p:pic>
      <p:sp>
        <p:nvSpPr>
          <p:cNvPr id="52" name="TextBox 4"/>
          <p:cNvSpPr/>
          <p:nvPr/>
        </p:nvSpPr>
        <p:spPr>
          <a:xfrm>
            <a:off x="3432600" y="4522680"/>
            <a:ext cx="3193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7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3T19:06:23Z</dcterms:created>
  <dc:creator>Windows User</dc:creator>
  <dc:description/>
  <dc:language>en-US</dc:language>
  <cp:lastModifiedBy>Windows User</cp:lastModifiedBy>
  <dcterms:modified xsi:type="dcterms:W3CDTF">2012-03-12T14:15:27Z</dcterms:modified>
  <cp:revision>7</cp:revision>
  <dc:subject/>
  <dc:title>PowerPoint Presentation</dc:title>
</cp:coreProperties>
</file>